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8" d="100"/>
          <a:sy n="78" d="100"/>
        </p:scale>
        <p:origin x="15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A6219C-28D0-7FBB-5F06-0A9FA35B10B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EAFF4D9-C2BF-A1AE-91F1-40237A560B3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E40D5C-099C-A3C2-4E8D-6B8CE08EBF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FD516-0836-4CAA-9D5B-A6C2B9C8044A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F2293D-F9A4-042F-8223-3C9457FDC2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603260-2860-30BD-2E8E-4C6690DF17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48376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4082DD-1B6D-41D0-40B4-F7B5AC5D88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E226772-620D-5115-D623-A3E615C59D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48A1F5-4F45-AC6D-8D6E-DC8F31E874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FD516-0836-4CAA-9D5B-A6C2B9C8044A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590CB9-1DA3-D68E-4262-0445A82BBF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681609-D629-8719-0887-B2AF2A721F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55388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2247798-4B69-6992-454C-CA4B228CD20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2E066E5-2365-0276-2481-029E455876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00B6FB-83FC-AFB9-49A1-6F25E6D2DD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FD516-0836-4CAA-9D5B-A6C2B9C8044A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BD5E8A-7FBF-B1F2-F8ED-652A970EE3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5DEA46-FA99-ABA9-5459-3C098DB5C6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79509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C94545-5B7E-F08F-6BE1-EC897FBDF4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A5C344-980A-009E-8790-D692EDFAA02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82EE9B-9678-61F6-6762-519400710A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FD516-0836-4CAA-9D5B-A6C2B9C8044A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6D13E5-9144-8935-5BD5-6C23A061CB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186974-FC15-EDE6-F027-499B21D611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04624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AB63D4-708B-744E-D8CF-16AA9424B6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D5727F4-42B6-4835-BB0F-A6CF9022E5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BBA927-7252-905E-6539-4384AD5F11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FD516-0836-4CAA-9D5B-A6C2B9C8044A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AB8B71-864B-90BF-A237-EDDAB8DFCF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694A25-EB25-69D9-8D34-88A90BEEA0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40418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D89E09-F188-C3F2-2D07-AFDC7FF942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55E71F-6176-6510-71E7-5CC7BCF5512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AA2AE7E-DF53-2F3F-1642-84C6CE462B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A33882-C063-338B-D02A-3C5E991304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FD516-0836-4CAA-9D5B-A6C2B9C8044A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CB70AD6-2A6A-E91F-7013-9026A84D78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D2A0A1-0D2F-DD37-E804-F2C93B8FDA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26941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17DD43-ACF4-E0BF-EAC6-B66AEB4131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8129C15-1026-D96F-5A1C-D32E1E0374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789C397-935E-6223-A80F-C2EB0B37DF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AEF8A7D-B43E-7BFF-1EDE-6209D09DF1C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D83D2A2-64A2-20DE-7241-2F56BC22F08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1597D6B-E29A-9784-8181-A0E38D6C29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FD516-0836-4CAA-9D5B-A6C2B9C8044A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B12483F-A6FB-BF8B-6F44-51D59DDE90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336BB3D-E719-7DD9-53A4-19389A581F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4561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BB7B7C-864B-2B6C-7D12-39C6EC1453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2B3F36B-C5B2-126F-E955-C2D33309D5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FD516-0836-4CAA-9D5B-A6C2B9C8044A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72AB72F-ACFD-5261-11E8-C73F9E5E23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D8FF429-8470-26DF-1E22-D6D1AC0298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3915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6A041A6-9E92-9D25-6C71-4224A6A5CE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FD516-0836-4CAA-9D5B-A6C2B9C8044A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7C44AE3-7EFC-CA14-E62C-D4EDE3E5BF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A321406-4AAC-E446-853F-501CA8DD85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87880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578274-C6C3-041E-AA75-95EA4DE6FB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3BB9D1-CADD-A742-2DB6-CBF78C5B41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9E64A8-1310-5315-7903-1362EFE66AB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4BA840E-6850-A3F7-D105-CBE513C5C0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FD516-0836-4CAA-9D5B-A6C2B9C8044A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BA76949-D9D2-085D-5CD8-12C647312C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962DBB-B051-A759-EE1C-405D675059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23836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B8490A-0287-3A0C-366F-95E9790CA4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E1F8AC2-BF34-DB6B-8340-D9C7BF59DC0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672564C-365F-AE9C-8E1D-1A6A245C64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2A1D1D7-5CC5-B5E7-4DC9-8AC5264ED9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3FD516-0836-4CAA-9D5B-A6C2B9C8044A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69B8DA-3F59-19E0-D3E0-5A32F30D36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36430E-CAC2-F891-8E7C-7F33B0A0D6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57999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AB2867D-D19E-9959-13B1-692DFE5B5C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811ED2-5C3A-9662-62D5-9EAFD61126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5B2104-DF6C-0372-0199-37605C26CF5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F3FD516-0836-4CAA-9D5B-A6C2B9C8044A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FFA202-3DD9-A530-40F3-6EB77AFDAE5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66C4AF-6A13-57C2-334D-9E98B95227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92BE336-20CE-47D9-B9A1-72DE949DCA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52578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30F09FA4-CE4F-E046-617A-A3502EF2394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5317" y="4354710"/>
            <a:ext cx="8634717" cy="1864167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58A8271A-1798-29D6-59A7-8EDDFEBBDF7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27537" b="48645"/>
          <a:stretch/>
        </p:blipFill>
        <p:spPr>
          <a:xfrm>
            <a:off x="1161980" y="1436576"/>
            <a:ext cx="8151404" cy="2118040"/>
          </a:xfrm>
          <a:prstGeom prst="rect">
            <a:avLst/>
          </a:prstGeom>
        </p:spPr>
      </p:pic>
      <p:sp>
        <p:nvSpPr>
          <p:cNvPr id="16" name="Rectangle 15">
            <a:extLst>
              <a:ext uri="{FF2B5EF4-FFF2-40B4-BE49-F238E27FC236}">
                <a16:creationId xmlns:a16="http://schemas.microsoft.com/office/drawing/2014/main" id="{6A4C7A06-6D49-F122-123C-F7ED60E122EA}"/>
              </a:ext>
            </a:extLst>
          </p:cNvPr>
          <p:cNvSpPr/>
          <p:nvPr/>
        </p:nvSpPr>
        <p:spPr>
          <a:xfrm>
            <a:off x="1553497" y="2561683"/>
            <a:ext cx="6459792" cy="571284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C64E34F-6FF8-894A-D6A6-B62BFD318698}"/>
              </a:ext>
            </a:extLst>
          </p:cNvPr>
          <p:cNvSpPr txBox="1"/>
          <p:nvPr/>
        </p:nvSpPr>
        <p:spPr>
          <a:xfrm>
            <a:off x="290335" y="2055244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7B3BC4F-E78C-45A4-1917-475F87E605BF}"/>
              </a:ext>
            </a:extLst>
          </p:cNvPr>
          <p:cNvSpPr txBox="1"/>
          <p:nvPr/>
        </p:nvSpPr>
        <p:spPr>
          <a:xfrm>
            <a:off x="290335" y="2512159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40ED5CD-DAEC-9BCA-5E4F-2543507E9928}"/>
              </a:ext>
            </a:extLst>
          </p:cNvPr>
          <p:cNvSpPr txBox="1"/>
          <p:nvPr/>
        </p:nvSpPr>
        <p:spPr>
          <a:xfrm>
            <a:off x="290335" y="3132969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28E3AC2-2E42-1C0A-FDB3-39181A2BC900}"/>
              </a:ext>
            </a:extLst>
          </p:cNvPr>
          <p:cNvSpPr txBox="1"/>
          <p:nvPr/>
        </p:nvSpPr>
        <p:spPr>
          <a:xfrm>
            <a:off x="2632724" y="763806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SCDko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128CF77-EF2D-7174-D11B-E078CED3ABB7}"/>
              </a:ext>
            </a:extLst>
          </p:cNvPr>
          <p:cNvSpPr txBox="1"/>
          <p:nvPr/>
        </p:nvSpPr>
        <p:spPr>
          <a:xfrm>
            <a:off x="84097" y="5620517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46CAB05-B4E9-79DC-B1D7-3F50C86DAD70}"/>
              </a:ext>
            </a:extLst>
          </p:cNvPr>
          <p:cNvSpPr txBox="1"/>
          <p:nvPr/>
        </p:nvSpPr>
        <p:spPr>
          <a:xfrm>
            <a:off x="84097" y="5267379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EBFDE38-A465-23DF-75A4-111FF8B7286E}"/>
              </a:ext>
            </a:extLst>
          </p:cNvPr>
          <p:cNvSpPr txBox="1"/>
          <p:nvPr/>
        </p:nvSpPr>
        <p:spPr>
          <a:xfrm>
            <a:off x="84097" y="5001041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180 </a:t>
            </a:r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E8A608DC-39B3-93FD-CD4C-CAFABE727CF2}"/>
              </a:ext>
            </a:extLst>
          </p:cNvPr>
          <p:cNvSpPr txBox="1"/>
          <p:nvPr/>
        </p:nvSpPr>
        <p:spPr>
          <a:xfrm>
            <a:off x="609638" y="150626"/>
            <a:ext cx="304442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Immunoblot against SCD </a:t>
            </a:r>
          </a:p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bcam, #ab19862, 1:1000</a:t>
            </a: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39945F6-07FE-3AB7-B472-76FF626C9FB1}"/>
              </a:ext>
            </a:extLst>
          </p:cNvPr>
          <p:cNvSpPr txBox="1"/>
          <p:nvPr/>
        </p:nvSpPr>
        <p:spPr>
          <a:xfrm>
            <a:off x="290335" y="3745706"/>
            <a:ext cx="416726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mmunoblot against vinculin</a:t>
            </a:r>
          </a:p>
          <a:p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1:2000, Merck, # SAB4200080)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E4933A1-90D0-FAD4-460F-A344627B7CFF}"/>
              </a:ext>
            </a:extLst>
          </p:cNvPr>
          <p:cNvSpPr txBox="1"/>
          <p:nvPr/>
        </p:nvSpPr>
        <p:spPr>
          <a:xfrm>
            <a:off x="9470202" y="2652827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CD</a:t>
            </a:r>
          </a:p>
        </p:txBody>
      </p: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B572620D-002A-DFF3-698D-03976D638141}"/>
              </a:ext>
            </a:extLst>
          </p:cNvPr>
          <p:cNvCxnSpPr>
            <a:cxnSpLocks/>
          </p:cNvCxnSpPr>
          <p:nvPr/>
        </p:nvCxnSpPr>
        <p:spPr>
          <a:xfrm flipH="1">
            <a:off x="9254392" y="2847325"/>
            <a:ext cx="28513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21206023-A4CD-2F1B-F811-AB64CEA898DC}"/>
              </a:ext>
            </a:extLst>
          </p:cNvPr>
          <p:cNvSpPr txBox="1"/>
          <p:nvPr/>
        </p:nvSpPr>
        <p:spPr>
          <a:xfrm>
            <a:off x="9563545" y="4980822"/>
            <a:ext cx="954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D4EB3D19-93EB-294E-7E31-54E799AE7383}"/>
              </a:ext>
            </a:extLst>
          </p:cNvPr>
          <p:cNvCxnSpPr>
            <a:cxnSpLocks/>
          </p:cNvCxnSpPr>
          <p:nvPr/>
        </p:nvCxnSpPr>
        <p:spPr>
          <a:xfrm flipH="1">
            <a:off x="9254392" y="5165488"/>
            <a:ext cx="28513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D1B8BDFE-EA20-BBFA-0C0F-57523BA8A47F}"/>
              </a:ext>
            </a:extLst>
          </p:cNvPr>
          <p:cNvSpPr txBox="1"/>
          <p:nvPr/>
        </p:nvSpPr>
        <p:spPr>
          <a:xfrm>
            <a:off x="1619502" y="1098878"/>
            <a:ext cx="63610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6         5         4         3          2         1        6         5          4         3         2         1 </a:t>
            </a: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CA49CBC6-13E6-AAF8-887A-D647301FAEBF}"/>
              </a:ext>
            </a:extLst>
          </p:cNvPr>
          <p:cNvCxnSpPr/>
          <p:nvPr/>
        </p:nvCxnSpPr>
        <p:spPr>
          <a:xfrm>
            <a:off x="1668662" y="1098878"/>
            <a:ext cx="29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E01FC0EC-843A-2FEB-9C53-32CCBC18C811}"/>
              </a:ext>
            </a:extLst>
          </p:cNvPr>
          <p:cNvCxnSpPr/>
          <p:nvPr/>
        </p:nvCxnSpPr>
        <p:spPr>
          <a:xfrm>
            <a:off x="4918234" y="1093959"/>
            <a:ext cx="29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BFA103A0-0827-9FA7-CB9C-0AC3C136E5D3}"/>
              </a:ext>
            </a:extLst>
          </p:cNvPr>
          <p:cNvSpPr txBox="1"/>
          <p:nvPr/>
        </p:nvSpPr>
        <p:spPr>
          <a:xfrm>
            <a:off x="5936416" y="731063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NTC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AFD6E65F-409C-ACDC-A17C-778C8AED5151}"/>
              </a:ext>
            </a:extLst>
          </p:cNvPr>
          <p:cNvSpPr/>
          <p:nvPr/>
        </p:nvSpPr>
        <p:spPr>
          <a:xfrm rot="21480000">
            <a:off x="1523809" y="5235225"/>
            <a:ext cx="6538954" cy="402219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22165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50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obias Ackermann</dc:creator>
  <cp:lastModifiedBy>Tobias Ackermann</cp:lastModifiedBy>
  <cp:revision>2</cp:revision>
  <dcterms:created xsi:type="dcterms:W3CDTF">2024-06-19T15:40:59Z</dcterms:created>
  <dcterms:modified xsi:type="dcterms:W3CDTF">2024-06-19T16:37:42Z</dcterms:modified>
</cp:coreProperties>
</file>